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3425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4263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11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1981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7794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101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4365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1026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046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649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1014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87C-B819-4491-98BD-3E178353D78E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2F08B-C555-47B3-BC91-50168F3AAE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34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矩形 25"/>
          <p:cNvSpPr/>
          <p:nvPr/>
        </p:nvSpPr>
        <p:spPr>
          <a:xfrm>
            <a:off x="5052279" y="1505544"/>
            <a:ext cx="935830" cy="86027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white"/>
              </a:solidFill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213376" y="1486466"/>
            <a:ext cx="5781997" cy="2189065"/>
            <a:chOff x="323528" y="1646193"/>
            <a:chExt cx="5781997" cy="2189065"/>
          </a:xfrm>
        </p:grpSpPr>
        <p:sp>
          <p:nvSpPr>
            <p:cNvPr id="3" name="TextBox 2"/>
            <p:cNvSpPr txBox="1"/>
            <p:nvPr/>
          </p:nvSpPr>
          <p:spPr>
            <a:xfrm>
              <a:off x="2271713" y="1665271"/>
              <a:ext cx="383381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CCUGUGC </a:t>
              </a:r>
              <a:r>
                <a:rPr lang="en-US" altLang="zh-CN" dirty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GCCUGCUGCC CG 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G</a:t>
              </a:r>
            </a:p>
            <a:p>
              <a:endParaRPr lang="en-US" altLang="zh-CN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endParaRPr>
            </a:p>
            <a:p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UGAUAUGUUGGAUGAUGGAGU </a:t>
              </a:r>
              <a:endParaRPr lang="zh-CN" altLang="en-US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endParaRPr>
            </a:p>
          </p:txBody>
        </p:sp>
        <p:cxnSp>
          <p:nvCxnSpPr>
            <p:cNvPr id="4" name="直接连接符 3"/>
            <p:cNvCxnSpPr/>
            <p:nvPr/>
          </p:nvCxnSpPr>
          <p:spPr>
            <a:xfrm>
              <a:off x="2574131" y="1985251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接连接符 4"/>
            <p:cNvCxnSpPr/>
            <p:nvPr/>
          </p:nvCxnSpPr>
          <p:spPr>
            <a:xfrm>
              <a:off x="2690018" y="1985250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/>
            <p:cNvCxnSpPr/>
            <p:nvPr/>
          </p:nvCxnSpPr>
          <p:spPr>
            <a:xfrm>
              <a:off x="2971005" y="1985251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/>
            <p:cNvCxnSpPr/>
            <p:nvPr/>
          </p:nvCxnSpPr>
          <p:spPr>
            <a:xfrm>
              <a:off x="3251993" y="1985250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>
              <a:off x="3673474" y="1985250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/>
            <p:cNvCxnSpPr/>
            <p:nvPr/>
          </p:nvCxnSpPr>
          <p:spPr>
            <a:xfrm>
              <a:off x="3804443" y="1985249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3938586" y="1985251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4218780" y="1992094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4347368" y="1985248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4628356" y="1985247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>
              <a:off x="4768849" y="1992093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/>
            <p:cNvCxnSpPr/>
            <p:nvPr/>
          </p:nvCxnSpPr>
          <p:spPr>
            <a:xfrm>
              <a:off x="5042693" y="1985246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395536" y="1665271"/>
              <a:ext cx="16356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mdop2</a:t>
              </a:r>
              <a:r>
                <a:rPr lang="en-US" altLang="zh-CN" sz="1600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CR-wt</a:t>
              </a:r>
              <a:endParaRPr lang="zh-CN" altLang="en-US" sz="1600" dirty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17332" y="2186990"/>
              <a:ext cx="10801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me-let-7</a:t>
              </a:r>
              <a:endParaRPr lang="zh-CN" altLang="en-US" sz="1600" i="1" dirty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57405" y="1665258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5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505449" y="1646193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3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57405" y="2186990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3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505449" y="2186990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5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45525" y="2911928"/>
              <a:ext cx="383381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C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TA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GUG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A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 GC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T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UGC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C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G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T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C </a:t>
              </a:r>
              <a:r>
                <a:rPr lang="en-US" altLang="zh-CN" b="1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T</a:t>
              </a:r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G G</a:t>
              </a:r>
            </a:p>
            <a:p>
              <a:endParaRPr lang="en-US" altLang="zh-CN" dirty="0" smtClean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endParaRPr>
            </a:p>
            <a:p>
              <a:r>
                <a:rPr lang="en-US" altLang="zh-CN" dirty="0" smtClean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rPr>
                <a:t>UGAUAUGUUGGAUGAUGGAGU </a:t>
              </a:r>
              <a:endParaRPr lang="zh-CN" altLang="en-US" dirty="0">
                <a:solidFill>
                  <a:prstClr val="black"/>
                </a:solidFill>
                <a:latin typeface="Courier New" pitchFamily="49" charset="0"/>
                <a:cs typeface="Courier New" pitchFamily="49" charset="0"/>
              </a:endParaRPr>
            </a:p>
          </p:txBody>
        </p:sp>
        <p:cxnSp>
          <p:nvCxnSpPr>
            <p:cNvPr id="25" name="直接连接符 24"/>
            <p:cNvCxnSpPr/>
            <p:nvPr/>
          </p:nvCxnSpPr>
          <p:spPr>
            <a:xfrm>
              <a:off x="2944817" y="3231908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/>
            <p:nvPr/>
          </p:nvCxnSpPr>
          <p:spPr>
            <a:xfrm>
              <a:off x="3647286" y="3231907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/>
            <p:nvPr/>
          </p:nvCxnSpPr>
          <p:spPr>
            <a:xfrm>
              <a:off x="3912398" y="3231908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/>
            <p:cNvCxnSpPr/>
            <p:nvPr/>
          </p:nvCxnSpPr>
          <p:spPr>
            <a:xfrm>
              <a:off x="4192592" y="3238751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4742661" y="3238750"/>
              <a:ext cx="0" cy="28336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323528" y="2911928"/>
              <a:ext cx="17076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mdop2-CR-mut</a:t>
              </a:r>
              <a:endParaRPr lang="zh-CN" altLang="en-US" sz="1600" i="1" dirty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83568" y="3411691"/>
              <a:ext cx="136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 Ame-let-7</a:t>
              </a:r>
              <a:endParaRPr lang="zh-CN" altLang="en-US" i="1" dirty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031217" y="2911915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5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479261" y="2892850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3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031217" y="3433647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3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479261" y="3433647"/>
              <a:ext cx="309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prstClr val="black"/>
                  </a:solidFill>
                </a:rPr>
                <a:t>5’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97932" y="3246192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544760" y="3246191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082922" y="3238756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07641" y="3231908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180676" y="3230584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458469" y="3230584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864906" y="3231903"/>
              <a:ext cx="2333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solidFill>
                    <a:prstClr val="black"/>
                  </a:solidFill>
                </a:rPr>
                <a:t>*</a:t>
              </a:r>
              <a:endParaRPr lang="zh-CN" altLang="en-US" sz="1400" dirty="0">
                <a:solidFill>
                  <a:prstClr val="black"/>
                </a:solidFill>
              </a:endParaRPr>
            </a:p>
          </p:txBody>
        </p:sp>
      </p:grpSp>
      <p:sp>
        <p:nvSpPr>
          <p:cNvPr id="24" name="矩形 23"/>
          <p:cNvSpPr/>
          <p:nvPr/>
        </p:nvSpPr>
        <p:spPr>
          <a:xfrm>
            <a:off x="1043608" y="1383159"/>
            <a:ext cx="6048672" cy="237626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white"/>
              </a:solidFill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179512" y="4437112"/>
            <a:ext cx="83529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696207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</Words>
  <Application>Microsoft Office PowerPoint</Application>
  <PresentationFormat>全屏显示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20200304</dc:creator>
  <cp:lastModifiedBy>admin20200304</cp:lastModifiedBy>
  <cp:revision>5</cp:revision>
  <dcterms:created xsi:type="dcterms:W3CDTF">2023-11-16T06:32:03Z</dcterms:created>
  <dcterms:modified xsi:type="dcterms:W3CDTF">2023-11-21T09:30:09Z</dcterms:modified>
</cp:coreProperties>
</file>